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5" r:id="rId2"/>
  </p:sldIdLst>
  <p:sldSz cx="6858000" cy="9144000" type="screen4x3"/>
  <p:notesSz cx="7104063" cy="10234613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21">
          <p15:clr>
            <a:srgbClr val="A4A3A4"/>
          </p15:clr>
        </p15:guide>
        <p15:guide id="2" pos="225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223" userDrawn="1">
          <p15:clr>
            <a:srgbClr val="A4A3A4"/>
          </p15:clr>
        </p15:guide>
        <p15:guide id="2" pos="2237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 autoAdjust="0"/>
    <p:restoredTop sz="86454" autoAdjust="0"/>
  </p:normalViewPr>
  <p:slideViewPr>
    <p:cSldViewPr showGuides="1">
      <p:cViewPr varScale="1">
        <p:scale>
          <a:sx n="96" d="100"/>
          <a:sy n="96" d="100"/>
        </p:scale>
        <p:origin x="3328" y="192"/>
      </p:cViewPr>
      <p:guideLst>
        <p:guide orient="horz" pos="2921"/>
        <p:guide pos="225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howGuides="1">
      <p:cViewPr varScale="1">
        <p:scale>
          <a:sx n="57" d="100"/>
          <a:sy n="57" d="100"/>
        </p:scale>
        <p:origin x="3216" y="192"/>
      </p:cViewPr>
      <p:guideLst>
        <p:guide orient="horz" pos="3223"/>
        <p:guide pos="2237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/Users/wm/Downloads/&#26032;&#24314;%20XLS%20&#24037;&#20316;&#34920;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wm/Downloads/&#26032;&#24314;%20XLS%20&#24037;&#20316;&#34920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>
                <a:solidFill>
                  <a:schemeClr val="tx1"/>
                </a:solidFill>
              </a:rPr>
              <a:t>Jag2</a:t>
            </a:r>
            <a:endParaRPr lang="zh-CN" altLang="en-US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39189189189189189"/>
          <c:y val="9.1743119266055051E-3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6536036036036036"/>
          <c:y val="0.12993137325724194"/>
          <c:w val="0.75470029084202328"/>
          <c:h val="0.7737997543884995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E327-A148-9E32-C490CC0A6AA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327-A148-9E32-C490CC0A6AA3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E327-A148-9E32-C490CC0A6AA3}"/>
                </c:ext>
              </c:extLst>
            </c:dLbl>
            <c:dLbl>
              <c:idx val="1"/>
              <c:layout>
                <c:manualLayout>
                  <c:x val="-0.21103603603603605"/>
                  <c:y val="-3.2110091743119268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200" b="0" i="0" u="none" strike="noStrike" kern="1200" baseline="0">
                        <a:solidFill>
                          <a:schemeClr val="tx1"/>
                        </a:solidFill>
                        <a:latin typeface="Times New Roman"/>
                        <a:ea typeface="+mn-ea"/>
                        <a:cs typeface="+mn-cs"/>
                      </a:defRPr>
                    </a:pPr>
                    <a:r>
                      <a:rPr lang="en-US" altLang="zh-CN" sz="1200">
                        <a:solidFill>
                          <a:schemeClr val="tx1"/>
                        </a:solidFill>
                        <a:latin typeface="Times New Roman"/>
                      </a:rPr>
                      <a:t>***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327-A148-9E32-C490CC0A6AA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B+L PCR'!$H$26:$H$27</c:f>
                <c:numCache>
                  <c:formatCode>General</c:formatCode>
                  <c:ptCount val="2"/>
                  <c:pt idx="0">
                    <c:v>9.3072890000000005E-2</c:v>
                  </c:pt>
                  <c:pt idx="1">
                    <c:v>0.462224199999999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bg2">
                  <a:lumMod val="7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</c:errBars>
          <c:cat>
            <c:strRef>
              <c:f>'B+L PCR'!$F$26:$F$27</c:f>
              <c:strCache>
                <c:ptCount val="2"/>
                <c:pt idx="0">
                  <c:v>Control</c:v>
                </c:pt>
                <c:pt idx="1">
                  <c:v>BMP4/LIF</c:v>
                </c:pt>
              </c:strCache>
            </c:strRef>
          </c:cat>
          <c:val>
            <c:numRef>
              <c:f>'B+L PCR'!$G$26:$G$27</c:f>
              <c:numCache>
                <c:formatCode>General</c:formatCode>
                <c:ptCount val="2"/>
                <c:pt idx="0">
                  <c:v>1</c:v>
                </c:pt>
                <c:pt idx="1">
                  <c:v>8.834229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327-A148-9E32-C490CC0A6A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4"/>
        <c:overlap val="-94"/>
        <c:axId val="1847183168"/>
        <c:axId val="1"/>
      </c:barChart>
      <c:catAx>
        <c:axId val="1847183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"/>
        <c:crossesAt val="0"/>
        <c:auto val="1"/>
        <c:lblAlgn val="ctr"/>
        <c:lblOffset val="100"/>
        <c:tickMarkSkip val="20"/>
        <c:noMultiLvlLbl val="0"/>
      </c:catAx>
      <c:valAx>
        <c:axId val="1"/>
        <c:scaling>
          <c:orientation val="minMax"/>
          <c:max val="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+mn-cs"/>
                  </a:defRPr>
                </a:pPr>
                <a:r>
                  <a:rPr lang="en-US" altLang="zh-CN" sz="1050" b="0" i="0" baseline="0">
                    <a:solidFill>
                      <a:schemeClr val="tx1"/>
                    </a:solidFill>
                    <a:effectLst/>
                    <a:latin typeface="+mj-lt"/>
                  </a:rPr>
                  <a:t>mRNA relative expression</a:t>
                </a:r>
                <a:endParaRPr lang="zh-CN" altLang="zh-CN" sz="1050" b="0">
                  <a:solidFill>
                    <a:schemeClr val="tx1"/>
                  </a:solidFill>
                  <a:effectLst/>
                  <a:latin typeface="+mj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pPr>
            <a:endParaRPr lang="zh-CN"/>
          </a:p>
        </c:txPr>
        <c:crossAx val="1847183168"/>
        <c:crosses val="autoZero"/>
        <c:crossBetween val="between"/>
        <c:majorUnit val="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>
                <a:solidFill>
                  <a:schemeClr val="tx1"/>
                </a:solidFill>
              </a:rPr>
              <a:t>Ngn1</a:t>
            </a:r>
            <a:endParaRPr lang="zh-CN" altLang="en-US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37387387387387389"/>
          <c:y val="4.5871559633027525E-3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4735759381428676"/>
          <c:y val="3.3601098027884128E-2"/>
          <c:w val="0.75470029084202328"/>
          <c:h val="0.8701300296178573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4963-414B-B5B7-9C0D9E03541F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784-B34D-B69A-C835438271D1}"/>
              </c:ext>
            </c:extLst>
          </c:dPt>
          <c:errBars>
            <c:errBarType val="plus"/>
            <c:errValType val="cust"/>
            <c:noEndCap val="0"/>
            <c:plus>
              <c:numRef>
                <c:f>'B+L PCR'!$H$23:$H$24</c:f>
                <c:numCache>
                  <c:formatCode>General</c:formatCode>
                  <c:ptCount val="2"/>
                  <c:pt idx="0">
                    <c:v>0.18703929999999999</c:v>
                  </c:pt>
                  <c:pt idx="1">
                    <c:v>0.100858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bg2">
                  <a:lumMod val="7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</c:errBars>
          <c:cat>
            <c:strRef>
              <c:f>'B+L PCR'!$F$23:$F$24</c:f>
              <c:strCache>
                <c:ptCount val="2"/>
                <c:pt idx="0">
                  <c:v>Control</c:v>
                </c:pt>
                <c:pt idx="1">
                  <c:v>BMP4/LIF</c:v>
                </c:pt>
              </c:strCache>
            </c:strRef>
          </c:cat>
          <c:val>
            <c:numRef>
              <c:f>'B+L PCR'!$G$23:$G$24</c:f>
              <c:numCache>
                <c:formatCode>General</c:formatCode>
                <c:ptCount val="2"/>
                <c:pt idx="0">
                  <c:v>1</c:v>
                </c:pt>
                <c:pt idx="1">
                  <c:v>1.110322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784-B34D-B69A-C835438271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4"/>
        <c:overlap val="-94"/>
        <c:axId val="1847183168"/>
        <c:axId val="1"/>
      </c:barChart>
      <c:catAx>
        <c:axId val="1847183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"/>
        <c:crossesAt val="0"/>
        <c:auto val="1"/>
        <c:lblAlgn val="ctr"/>
        <c:lblOffset val="100"/>
        <c:tickMarkSkip val="20"/>
        <c:noMultiLvlLbl val="0"/>
      </c:catAx>
      <c:valAx>
        <c:axId val="1"/>
        <c:scaling>
          <c:orientation val="minMax"/>
          <c:max val="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+mn-cs"/>
                  </a:defRPr>
                </a:pPr>
                <a:r>
                  <a:rPr lang="en-US" altLang="zh-CN" sz="1050" b="0" i="0" baseline="0">
                    <a:solidFill>
                      <a:schemeClr val="tx1"/>
                    </a:solidFill>
                    <a:effectLst/>
                    <a:latin typeface="+mj-lt"/>
                  </a:rPr>
                  <a:t>mRNA relative expression</a:t>
                </a:r>
                <a:endParaRPr lang="zh-CN" altLang="zh-CN" sz="1050" b="0">
                  <a:solidFill>
                    <a:schemeClr val="tx1"/>
                  </a:solidFill>
                  <a:effectLst/>
                  <a:latin typeface="+mj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pPr>
            <a:endParaRPr lang="zh-CN"/>
          </a:p>
        </c:txPr>
        <c:crossAx val="1847183168"/>
        <c:crosses val="autoZero"/>
        <c:crossBetween val="between"/>
        <c:majorUnit val="1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3656</cdr:x>
      <cdr:y>0.16054</cdr:y>
    </cdr:from>
    <cdr:to>
      <cdr:x>0.71434</cdr:x>
      <cdr:y>0.16513</cdr:y>
    </cdr:to>
    <cdr:cxnSp macro="">
      <cdr:nvCxnSpPr>
        <cdr:cNvPr id="3" name="直线连接符 2">
          <a:extLst xmlns:a="http://schemas.openxmlformats.org/drawingml/2006/main">
            <a:ext uri="{FF2B5EF4-FFF2-40B4-BE49-F238E27FC236}">
              <a16:creationId xmlns:a16="http://schemas.microsoft.com/office/drawing/2014/main" id="{46881AF6-99E5-C542-8DC2-4D3BAAD4A4C8}"/>
            </a:ext>
          </a:extLst>
        </cdr:cNvPr>
        <cdr:cNvCxnSpPr/>
      </cdr:nvCxnSpPr>
      <cdr:spPr>
        <a:xfrm xmlns:a="http://schemas.openxmlformats.org/drawingml/2006/main" flipV="1">
          <a:off x="948902" y="444470"/>
          <a:ext cx="1065113" cy="12707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>
            <a:extLst>
              <a:ext uri="{FF2B5EF4-FFF2-40B4-BE49-F238E27FC236}">
                <a16:creationId xmlns:a16="http://schemas.microsoft.com/office/drawing/2014/main" id="{C33B2C9D-C7A1-814D-9E28-5D6F47D59D56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l" eaLnBrk="0" hangingPunct="0">
              <a:buFontTx/>
              <a:buNone/>
              <a:defRPr sz="13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AFC3B36-7CEC-A540-AACA-C88106FB6ACF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r" eaLnBrk="0" hangingPunct="0">
              <a:buFontTx/>
              <a:buNone/>
              <a:defRPr sz="13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幻灯片图像占位符 3">
            <a:extLst>
              <a:ext uri="{FF2B5EF4-FFF2-40B4-BE49-F238E27FC236}">
                <a16:creationId xmlns:a16="http://schemas.microsoft.com/office/drawing/2014/main" id="{9BCDC2A3-E81C-E94C-A001-25A6432CBA1D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257425" y="1279525"/>
            <a:ext cx="2589213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75" tIns="49538" rIns="99075" bIns="49538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>
            <a:extLst>
              <a:ext uri="{FF2B5EF4-FFF2-40B4-BE49-F238E27FC236}">
                <a16:creationId xmlns:a16="http://schemas.microsoft.com/office/drawing/2014/main" id="{E503FCEE-97C8-3C4A-9DC1-828FB81572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wrap="square" lIns="99075" tIns="49538" rIns="99075" bIns="49538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BB3DF01-EC2E-9442-B027-78084D21749F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l" eaLnBrk="0" hangingPunct="0">
              <a:buFontTx/>
              <a:buNone/>
              <a:defRPr sz="13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FF71DF9-7A3A-0E46-86AC-2CB49D2B9BA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wrap="square" lIns="99075" tIns="49538" rIns="99075" bIns="49538" numCol="1" anchor="b" anchorCtr="0" compatLnSpc="1"/>
          <a:lstStyle>
            <a:lvl1pPr algn="r" eaLnBrk="1" hangingPunct="1">
              <a:buFont typeface="Arial" panose="020B0604020202020204" pitchFamily="34" charset="0"/>
              <a:buNone/>
              <a:defRPr sz="1300" noProof="1"/>
            </a:lvl1pPr>
          </a:lstStyle>
          <a:p>
            <a:pPr>
              <a:defRPr/>
            </a:pPr>
            <a:fld id="{143DFE51-DDF4-1A46-BF40-7F3AAC24641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49" name="幻灯片图像占位符 1">
            <a:extLst>
              <a:ext uri="{FF2B5EF4-FFF2-40B4-BE49-F238E27FC236}">
                <a16:creationId xmlns:a16="http://schemas.microsoft.com/office/drawing/2014/main" id="{1978F180-C093-8B43-8535-B011BB246871}"/>
              </a:ext>
            </a:extLst>
          </p:cNvPr>
          <p:cNvSpPr>
            <a:spLocks noGrp="1" noRot="1" noChangeAspect="1" noChangeArrowheads="1" noTextEdit="1"/>
          </p:cNvSpPr>
          <p:nvPr>
            <p:ph type="sldImg" idx="4294967295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7650" name="备注占位符 2">
            <a:extLst>
              <a:ext uri="{FF2B5EF4-FFF2-40B4-BE49-F238E27FC236}">
                <a16:creationId xmlns:a16="http://schemas.microsoft.com/office/drawing/2014/main" id="{8DAAF399-349A-5947-9E44-3636B8B5B4E0}"/>
              </a:ext>
            </a:extLst>
          </p:cNvPr>
          <p:cNvSpPr>
            <a:spLocks noGrp="1" noChangeArrowheads="1"/>
          </p:cNvSpPr>
          <p:nvPr>
            <p:ph type="body" idx="429496729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endParaRPr lang="en-US" altLang="zh-CN"/>
          </a:p>
        </p:txBody>
      </p:sp>
      <p:sp>
        <p:nvSpPr>
          <p:cNvPr id="27651" name="灯片编号占位符 3">
            <a:extLst>
              <a:ext uri="{FF2B5EF4-FFF2-40B4-BE49-F238E27FC236}">
                <a16:creationId xmlns:a16="http://schemas.microsoft.com/office/drawing/2014/main" id="{E04AEF91-C65C-804B-8B9E-EFA5BC17A8AB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buFontTx/>
              <a:buNone/>
            </a:pPr>
            <a:fld id="{53EDC9FB-59A2-9B43-8E98-BDE6AB434D7D}" type="slidenum">
              <a:rPr altLang="en-US" smtClean="0"/>
              <a:pPr>
                <a:buFontTx/>
                <a:buNone/>
              </a:pPr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09379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noProof="1"/>
              <a:t>单击此处编辑母版副标题样式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6AF0E3F4-72D3-A44F-8352-E022DBB72DA8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6B7D42C8-301A-054D-BADE-8BA54B4706F4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F1220443-0457-1746-ACDA-236DABD40EF8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6C179F8-438E-1042-91A1-04B7169A9AA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90295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A82F24A7-3C29-5F4A-BC74-55BC6B3E5D38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F8956973-A1F0-FD43-A8A7-069788CA548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BD466D85-783D-0949-B891-015DA7176DD7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3AA04A5-9180-0249-9BFB-11BB769911C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86345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20F38303-447B-E643-A5C2-3E6F1375A63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6D36D1A8-7BD3-FC48-99B9-509A41BDCCC2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9AC276C4-D353-8B4F-9952-B7FC1F18E3E3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8D58E69-9F69-C347-9D7B-4F05A5D9C9AB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121395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AD2D118B-17BB-0641-AA6F-4AEF894A9360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28E61A31-8557-A545-89ED-F24CC3BF39A0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491DBA53-393F-324D-B362-F60EC43EAE73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7A1D615-F84B-464A-A99F-CF86677B2E0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506141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3CC8EA98-DE0D-B944-AF37-6690C73C1E20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302CC7F7-3DD3-8C46-B964-C727ECD01CC6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F1929EC4-7027-FA41-852C-42E5CA41B198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CAEB4CD-2EEF-2742-BF9B-21C6D4D45A3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990812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5D9CA7E-0B21-3B4C-9357-BC42BE0D085E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9124FDF-FCB9-CE4B-85E0-63831835B24B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CA30942-2FE8-5A40-A938-8CD26B01634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1135DA2-657B-6348-BB6A-A9950B87AF5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620408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FBFC5E34-8B59-B34C-8283-AD1ED8B40F5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85A7FEC8-D67F-EB49-A0DE-5EB110F8DBCD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41BB3FD2-D67C-2646-B32B-6657E3D45EE7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96D738-A5D9-3842-B928-D5F41BED38A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2720556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4B498B92-2844-314F-BD77-9C8E218ABDDF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F3FB3CEA-D461-5741-8C7D-6E2512C3F799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E0DC6315-0C9F-F14F-84B9-2500EFD75E22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40FD110-2A37-294B-B38B-189137EE30B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030344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2702F512-423D-1849-BF8F-559CE3CD059C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A581E8DD-06B0-824A-BF03-4AA956F03160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1D004BA2-A605-9847-B742-90C82EB2196C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953602-27B5-AE43-A8D8-4C9513F0AE9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443493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E0F799E-47A1-8244-B78D-5D1045B19B19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5B0FFAB-BF65-734C-B9FB-A5154E883FFD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68EDB9D-6819-DF4B-A0A8-2507C92A96B2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9804388-B73E-134F-9740-EC8D4BE8030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659371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267E07F-BC81-FD45-93B8-5366EFAE1247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E3589D9-6D72-7447-97BF-ED8E164AED2B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01FE2F9-FF4B-E842-AAF3-5869B5BE0BEE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46CFFF-510B-A443-9595-9FDE0E2B98CD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934503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6E3EA3AB-7A6B-9244-B09B-FB5097E23787}"/>
              </a:ext>
            </a:extLst>
          </p:cNvPr>
          <p:cNvSpPr>
            <a:spLocks noGrp="1" noChangeArrowheads="1"/>
          </p:cNvSpPr>
          <p:nvPr>
            <p:ph type="title" idx="4294967295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D637E71B-FF52-FD42-97B9-C86EDD91662A}"/>
              </a:ext>
            </a:extLst>
          </p:cNvPr>
          <p:cNvSpPr>
            <a:spLocks noGrp="1" noChangeArrowheads="1"/>
          </p:cNvSpPr>
          <p:nvPr>
            <p:ph type="body" idx="4294967295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F1399F7F-EE26-AF49-993B-24CD7CFD5A2D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eaLnBrk="1" hangingPunct="1">
              <a:buFontTx/>
              <a:buNone/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C82E187A-DC33-A24C-AF59-C46F63B1CB59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 eaLnBrk="1" hangingPunct="1">
              <a:buFontTx/>
              <a:buNone/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0E286FF1-5341-864F-B429-C2EE7E995CA4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 eaLnBrk="1" hangingPunct="1">
              <a:buFont typeface="Arial" panose="020B0604020202020204" pitchFamily="34" charset="0"/>
              <a:defRPr sz="1400" noProof="1"/>
            </a:lvl1pPr>
          </a:lstStyle>
          <a:p>
            <a:pPr>
              <a:defRPr/>
            </a:pPr>
            <a:fld id="{D40D56EC-9529-D54E-A339-16953DCEFBB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7" name="矩形 29">
            <a:extLst>
              <a:ext uri="{FF2B5EF4-FFF2-40B4-BE49-F238E27FC236}">
                <a16:creationId xmlns:a16="http://schemas.microsoft.com/office/drawing/2014/main" id="{50633AF4-AEAA-4641-A9E8-B779CA64AC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88" y="12700"/>
            <a:ext cx="229421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800" dirty="0">
                <a:latin typeface="Times New Roman" panose="02020603050405020304" pitchFamily="18" charset="0"/>
              </a:rPr>
              <a:t>Supplementary Fig. 1 </a:t>
            </a:r>
            <a:endParaRPr lang="zh-CN" altLang="en-US" sz="1800" dirty="0">
              <a:latin typeface="Times New Roman" panose="02020603050405020304" pitchFamily="18" charset="0"/>
            </a:endParaRPr>
          </a:p>
        </p:txBody>
      </p:sp>
      <p:sp>
        <p:nvSpPr>
          <p:cNvPr id="26628" name="矩形 1">
            <a:extLst>
              <a:ext uri="{FF2B5EF4-FFF2-40B4-BE49-F238E27FC236}">
                <a16:creationId xmlns:a16="http://schemas.microsoft.com/office/drawing/2014/main" id="{97FC7775-C419-3C44-BABA-75E5DE2AAF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2339" y="6694982"/>
            <a:ext cx="6702425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 The expression of Jag2(a) and Ngn1(b) in monkey NSCs treated with BMP4/LIF. *** 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0.001</a:t>
            </a:r>
            <a:r>
              <a:rPr lang="zh-CN" altLang="zh-CN" sz="16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5" name="图表 44">
            <a:extLst>
              <a:ext uri="{FF2B5EF4-FFF2-40B4-BE49-F238E27FC236}">
                <a16:creationId xmlns:a16="http://schemas.microsoft.com/office/drawing/2014/main" id="{3B9A2630-EACC-AD40-9B6D-48FE33B410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5236736"/>
              </p:ext>
            </p:extLst>
          </p:nvPr>
        </p:nvGraphicFramePr>
        <p:xfrm>
          <a:off x="734490" y="3197825"/>
          <a:ext cx="2819400" cy="2768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6" name="图表 45">
            <a:extLst>
              <a:ext uri="{FF2B5EF4-FFF2-40B4-BE49-F238E27FC236}">
                <a16:creationId xmlns:a16="http://schemas.microsoft.com/office/drawing/2014/main" id="{F3668898-9A6F-6D4C-B27F-54FD1FFEEB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5934274"/>
              </p:ext>
            </p:extLst>
          </p:nvPr>
        </p:nvGraphicFramePr>
        <p:xfrm>
          <a:off x="3583552" y="3206928"/>
          <a:ext cx="2819400" cy="2768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7" name="Text Box 33">
            <a:extLst>
              <a:ext uri="{FF2B5EF4-FFF2-40B4-BE49-F238E27FC236}">
                <a16:creationId xmlns:a16="http://schemas.microsoft.com/office/drawing/2014/main" id="{3EC72CC8-EE4D-D94E-AFDD-69A2C20858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10961" y="6180138"/>
            <a:ext cx="504825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600" dirty="0">
                <a:latin typeface="Times New Roman" panose="02020603050405020304" pitchFamily="18" charset="0"/>
                <a:sym typeface="宋体" panose="02010600030101010101" pitchFamily="2" charset="-122"/>
              </a:rPr>
              <a:t>(a)</a:t>
            </a:r>
          </a:p>
        </p:txBody>
      </p:sp>
      <p:sp>
        <p:nvSpPr>
          <p:cNvPr id="49" name="Text Box 33">
            <a:extLst>
              <a:ext uri="{FF2B5EF4-FFF2-40B4-BE49-F238E27FC236}">
                <a16:creationId xmlns:a16="http://schemas.microsoft.com/office/drawing/2014/main" id="{974F7E12-8165-0F46-ABB5-5AC7107120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69160" y="6144719"/>
            <a:ext cx="504825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600" dirty="0">
                <a:latin typeface="Times New Roman" panose="02020603050405020304" pitchFamily="18" charset="0"/>
                <a:sym typeface="宋体" panose="02010600030101010101" pitchFamily="2" charset="-122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1402318311"/>
      </p:ext>
    </p:extLst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52</TotalTime>
  <Pages>0</Pages>
  <Words>49</Words>
  <Characters>0</Characters>
  <Application>Microsoft Macintosh PowerPoint</Application>
  <DocSecurity>0</DocSecurity>
  <PresentationFormat>全屏显示(4:3)</PresentationFormat>
  <Lines>0</Lines>
  <Paragraphs>1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默认设计模板</vt:lpstr>
      <vt:lpstr>PowerPoint 演示文稿</vt:lpstr>
    </vt:vector>
  </TitlesOfParts>
  <Company>微软中国</Company>
  <LinksUpToDate>false</LinksUpToDate>
  <CharactersWithSpaces>0</CharactersWithSpaces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微软用户</dc:creator>
  <cp:lastModifiedBy>Microsoft Office User</cp:lastModifiedBy>
  <cp:revision>594</cp:revision>
  <cp:lastPrinted>2020-01-27T08:57:56Z</cp:lastPrinted>
  <dcterms:created xsi:type="dcterms:W3CDTF">2017-07-31T06:11:40Z</dcterms:created>
  <dcterms:modified xsi:type="dcterms:W3CDTF">2020-02-15T03:32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751</vt:lpwstr>
  </property>
</Properties>
</file>